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4AF3C-6B1C-4343-981E-0F6FB6B803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89F7E-D5FC-4750-AFA3-3EC8C53C3B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F10B6-EDE0-43F4-AB73-DC0C3075A6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B6E39-EDB6-4956-9238-E2AB4017A0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308DC-127E-4D0B-96D0-F908C4E4AE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EEFF9-4B4C-4D01-A14F-77DC8541A4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24842-856C-404B-A10A-55C1C4B621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B4FF2D-2F67-46B4-95C6-3E7FFA507D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9E9B1-F53F-4D2C-9E94-3843211C70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B9579-549F-4621-8553-F216B60078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BF8BC-D459-4235-A1B5-62274B4F8F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92FD5F-7B51-463B-80F8-8CE12E693F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C0DE7A-FAB2-4FDB-8B86-886EF1B3DD43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4360" y="6292800"/>
            <a:ext cx="792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Times New Roman"/>
              </a:rPr>
              <a:t>Fig. S1. Length distribution of contigs (A), scaffolds (B) and unigenes (C), GAP of the unigenes(D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4439520" y="3500280"/>
            <a:ext cx="4020120" cy="2662560"/>
            <a:chOff x="4439520" y="3500280"/>
            <a:chExt cx="4020120" cy="2662560"/>
          </a:xfrm>
        </p:grpSpPr>
        <p:sp>
          <p:nvSpPr>
            <p:cNvPr id="43" name=""/>
            <p:cNvSpPr/>
            <p:nvPr/>
          </p:nvSpPr>
          <p:spPr>
            <a:xfrm>
              <a:off x="6308640" y="5916600"/>
              <a:ext cx="885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GAP (N/size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439520" y="4083120"/>
              <a:ext cx="332640" cy="1031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</a:rPr>
                <a:t>Unigene numb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955400" y="5616720"/>
              <a:ext cx="332640" cy="22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149080" y="5611680"/>
              <a:ext cx="332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383800" y="562140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0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59188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0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80320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01416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23808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460200" y="562608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641280" y="562608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84756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1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09992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730152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751608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71444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791604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2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8127000" y="5616720"/>
              <a:ext cx="33264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.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045040" y="3556080"/>
              <a:ext cx="3397320" cy="2016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045040" y="5172120"/>
              <a:ext cx="339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045040" y="4762440"/>
              <a:ext cx="339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045040" y="4362480"/>
              <a:ext cx="339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045040" y="3954600"/>
              <a:ext cx="339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045040" y="3556080"/>
              <a:ext cx="339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045040" y="3556080"/>
              <a:ext cx="3397320" cy="2016000"/>
            </a:xfrm>
            <a:prstGeom prst="rect">
              <a:avLst/>
            </a:pr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076720" y="3627360"/>
              <a:ext cx="39960" cy="194472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181480" y="4498920"/>
              <a:ext cx="46080" cy="10731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292720" y="4498920"/>
              <a:ext cx="39600" cy="10731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397480" y="4475160"/>
              <a:ext cx="39600" cy="109692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502240" y="4475160"/>
              <a:ext cx="38160" cy="109692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605560" y="4516560"/>
              <a:ext cx="47520" cy="105552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718240" y="4498920"/>
              <a:ext cx="39600" cy="10731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821200" y="4540320"/>
              <a:ext cx="39960" cy="10317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924520" y="4540320"/>
              <a:ext cx="41400" cy="10317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029280" y="4562640"/>
              <a:ext cx="49320" cy="100944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141960" y="4578480"/>
              <a:ext cx="39600" cy="99360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245280" y="4603680"/>
              <a:ext cx="41400" cy="96840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350040" y="4603680"/>
              <a:ext cx="41400" cy="96840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6454800" y="4619520"/>
              <a:ext cx="47520" cy="9525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6566040" y="4635360"/>
              <a:ext cx="41040" cy="93672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6670800" y="4619520"/>
              <a:ext cx="41040" cy="9525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6775560" y="4649760"/>
              <a:ext cx="39600" cy="92232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6878520" y="4643280"/>
              <a:ext cx="49320" cy="92880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6991200" y="4675320"/>
              <a:ext cx="41400" cy="8967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095960" y="4683240"/>
              <a:ext cx="39960" cy="88884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7199280" y="4714920"/>
              <a:ext cx="41400" cy="8571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7304040" y="4778280"/>
              <a:ext cx="49320" cy="79380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7416720" y="4843440"/>
              <a:ext cx="39600" cy="72864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7520040" y="4948200"/>
              <a:ext cx="41400" cy="62388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7624800" y="5027760"/>
              <a:ext cx="41400" cy="54432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7729560" y="5172120"/>
              <a:ext cx="47520" cy="39996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7840800" y="5156280"/>
              <a:ext cx="41040" cy="41580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7945560" y="5380200"/>
              <a:ext cx="41040" cy="19188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8050320" y="5451480"/>
              <a:ext cx="39600" cy="12060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8153280" y="5451480"/>
              <a:ext cx="47880" cy="12060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8265960" y="5451480"/>
              <a:ext cx="39960" cy="120600"/>
            </a:xfrm>
            <a:prstGeom prst="rect">
              <a:avLst/>
            </a:prstGeom>
            <a:solidFill>
              <a:srgbClr val="0000ff"/>
            </a:solidFill>
            <a:ln w="7920">
              <a:solidFill>
                <a:srgbClr val="0000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045040" y="3556080"/>
              <a:ext cx="0" cy="2016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045040" y="55720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045040" y="54514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045040" y="53802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5045040" y="53308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045040" y="52912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045040" y="52592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045040" y="522756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045040" y="520236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5045040" y="518652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045040" y="517212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045040" y="50436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045040" y="49784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045040" y="49230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5045040" y="48830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045040" y="485136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045040" y="48276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5045040" y="48038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5045040" y="47862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045040" y="47624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045040" y="46432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5045040" y="457056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045040" y="45244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045040" y="44830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045040" y="44514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045040" y="44276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5045040" y="44038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5045040" y="437976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5045040" y="43624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045040" y="424332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5045040" y="41720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5045040" y="41162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5045040" y="408312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5045040" y="40514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5045040" y="40194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5045040" y="39956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5045040" y="39798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5045040" y="39546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5045040" y="38354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5045040" y="37638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5045040" y="37148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5045040" y="36766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5045040" y="364320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5045040" y="361944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5045040" y="35956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045040" y="357192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045040" y="3556080"/>
              <a:ext cx="316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5045040" y="5572080"/>
              <a:ext cx="39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5045040" y="5172120"/>
              <a:ext cx="39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5045040" y="4762440"/>
              <a:ext cx="39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5045040" y="4362480"/>
              <a:ext cx="39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5045040" y="3954600"/>
              <a:ext cx="39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5045040" y="3556080"/>
              <a:ext cx="39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5045040" y="5572080"/>
              <a:ext cx="3397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504504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514836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526104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536580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flipV="1">
              <a:off x="546876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557388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 flipV="1">
              <a:off x="568656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578952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flipV="1">
              <a:off x="589428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flipV="1">
              <a:off x="599760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 flipV="1">
              <a:off x="611028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flipV="1">
              <a:off x="621504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 flipV="1">
              <a:off x="631836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 flipV="1">
              <a:off x="642312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 flipV="1">
              <a:off x="653580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 flipV="1">
              <a:off x="664056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 flipV="1">
              <a:off x="674388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flipV="1">
              <a:off x="684864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flipV="1">
              <a:off x="695952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flipV="1">
              <a:off x="706284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flipV="1">
              <a:off x="716760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flipV="1">
              <a:off x="727092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flipV="1">
              <a:off x="738360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flipV="1">
              <a:off x="748836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V="1">
              <a:off x="759132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flipV="1">
              <a:off x="769608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flipV="1">
              <a:off x="780876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flipV="1">
              <a:off x="791208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flipV="1">
              <a:off x="801684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flipV="1">
              <a:off x="812160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flipV="1">
              <a:off x="823284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flipV="1">
              <a:off x="833760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 flipV="1">
              <a:off x="8442360" y="5530320"/>
              <a:ext cx="0" cy="41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880520" y="544680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宋体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811400" y="51148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宋体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743720" y="47070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宋体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674600" y="4308480"/>
              <a:ext cx="28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宋体"/>
                </a:rPr>
                <a:t>1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606920" y="3900600"/>
              <a:ext cx="35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宋体"/>
                </a:rPr>
                <a:t>1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539240" y="3500280"/>
              <a:ext cx="43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宋体"/>
                </a:rPr>
                <a:t>10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7885080" y="3597120"/>
              <a:ext cx="432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3" name=""/>
          <p:cNvGrpSpPr/>
          <p:nvPr/>
        </p:nvGrpSpPr>
        <p:grpSpPr>
          <a:xfrm>
            <a:off x="227880" y="3349800"/>
            <a:ext cx="4128120" cy="2744640"/>
            <a:chOff x="227880" y="3349800"/>
            <a:chExt cx="4128120" cy="2744640"/>
          </a:xfrm>
        </p:grpSpPr>
        <p:graphicFrame>
          <p:nvGraphicFramePr>
            <p:cNvPr id="194" name=""/>
            <p:cNvGraphicFramePr/>
            <p:nvPr/>
          </p:nvGraphicFramePr>
          <p:xfrm>
            <a:off x="258840" y="3349800"/>
            <a:ext cx="4097160" cy="262404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195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58840" y="3349800"/>
                      <a:ext cx="4097160" cy="2624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96" name=""/>
            <p:cNvSpPr/>
            <p:nvPr/>
          </p:nvSpPr>
          <p:spPr>
            <a:xfrm>
              <a:off x="1487520" y="5848200"/>
              <a:ext cx="2211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</a:rPr>
                <a:t>Unigene length distribution (bp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227880" y="3975120"/>
              <a:ext cx="332640" cy="1093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</a:rPr>
                <a:t>Unigene numb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3708360" y="3597120"/>
              <a:ext cx="358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9" name=""/>
          <p:cNvGrpSpPr/>
          <p:nvPr/>
        </p:nvGrpSpPr>
        <p:grpSpPr>
          <a:xfrm>
            <a:off x="237240" y="545040"/>
            <a:ext cx="3927240" cy="2518920"/>
            <a:chOff x="237240" y="545040"/>
            <a:chExt cx="3927240" cy="2518920"/>
          </a:xfrm>
        </p:grpSpPr>
        <p:sp>
          <p:nvSpPr>
            <p:cNvPr id="200" name=""/>
            <p:cNvSpPr/>
            <p:nvPr/>
          </p:nvSpPr>
          <p:spPr>
            <a:xfrm>
              <a:off x="1603440" y="2817720"/>
              <a:ext cx="192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</a:rPr>
                <a:t>Contig length distribu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237240" y="949320"/>
              <a:ext cx="332640" cy="116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</a:rPr>
                <a:t>Contig numb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2" name=""/>
            <p:cNvGrpSpPr/>
            <p:nvPr/>
          </p:nvGrpSpPr>
          <p:grpSpPr>
            <a:xfrm>
              <a:off x="375840" y="545040"/>
              <a:ext cx="3788640" cy="2223360"/>
              <a:chOff x="375840" y="545040"/>
              <a:chExt cx="3788640" cy="2223360"/>
            </a:xfrm>
          </p:grpSpPr>
          <p:sp>
            <p:nvSpPr>
              <p:cNvPr id="203" name=""/>
              <p:cNvSpPr/>
              <p:nvPr/>
            </p:nvSpPr>
            <p:spPr>
              <a:xfrm>
                <a:off x="868320" y="589680"/>
                <a:ext cx="3296160" cy="1885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868320" y="2164680"/>
                <a:ext cx="3296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868320" y="1845360"/>
                <a:ext cx="3296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868320" y="1532880"/>
                <a:ext cx="3296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868320" y="1221840"/>
                <a:ext cx="3296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868320" y="902520"/>
                <a:ext cx="3296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868320" y="589680"/>
                <a:ext cx="3296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868320" y="589680"/>
                <a:ext cx="3296160" cy="188568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899640" y="730800"/>
                <a:ext cx="47880" cy="174456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1012680" y="1094400"/>
                <a:ext cx="38880" cy="138096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1116000" y="1206360"/>
                <a:ext cx="47880" cy="126900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1229040" y="1287000"/>
                <a:ext cx="47880" cy="118836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1339920" y="1353960"/>
                <a:ext cx="47520" cy="112140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1452600" y="1414440"/>
                <a:ext cx="40320" cy="10609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1556280" y="1458720"/>
                <a:ext cx="47520" cy="101664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1668960" y="1503360"/>
                <a:ext cx="47520" cy="97200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1779840" y="1554840"/>
                <a:ext cx="47880" cy="9205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1892520" y="1599840"/>
                <a:ext cx="40320" cy="87588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1996200" y="1629000"/>
                <a:ext cx="47880" cy="84636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2108880" y="1666800"/>
                <a:ext cx="47880" cy="80856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2219760" y="1711440"/>
                <a:ext cx="47520" cy="7639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2332800" y="1749240"/>
                <a:ext cx="40320" cy="7261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2436120" y="1785240"/>
                <a:ext cx="47520" cy="69048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2548800" y="1836360"/>
                <a:ext cx="47520" cy="63900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2659680" y="1859040"/>
                <a:ext cx="40320" cy="6163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2764800" y="1890000"/>
                <a:ext cx="47880" cy="5857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2876040" y="1941120"/>
                <a:ext cx="47880" cy="53424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2988720" y="1970280"/>
                <a:ext cx="47880" cy="50508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3099960" y="2001600"/>
                <a:ext cx="40320" cy="47376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3205080" y="2015280"/>
                <a:ext cx="47880" cy="46008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3315960" y="2075040"/>
                <a:ext cx="47520" cy="4003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3429000" y="2082240"/>
                <a:ext cx="47520" cy="3931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3539520" y="2164680"/>
                <a:ext cx="40320" cy="31068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3645360" y="2178360"/>
                <a:ext cx="47520" cy="29700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3755880" y="2290320"/>
                <a:ext cx="47880" cy="18504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3868560" y="2379240"/>
                <a:ext cx="47880" cy="961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3979800" y="2379240"/>
                <a:ext cx="40320" cy="9612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4084920" y="2111400"/>
                <a:ext cx="47880" cy="363960"/>
              </a:xfrm>
              <a:prstGeom prst="rect">
                <a:avLst/>
              </a:prstGeom>
              <a:solidFill>
                <a:srgbClr val="0000ff"/>
              </a:solidFill>
              <a:ln w="648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868320" y="589680"/>
                <a:ext cx="0" cy="1885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868320" y="24757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868320" y="23792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868320" y="23281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868320" y="22903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868320" y="22539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868320" y="22316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868320" y="22093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>
                <a:off x="868320" y="21938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868320" y="21783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868320" y="21646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868320" y="20667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868320" y="20080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868320" y="19702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868320" y="19411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>
                <a:off x="868320" y="19191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868320" y="18968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868320" y="18741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868320" y="18590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868320" y="18453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868320" y="17557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868320" y="16959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868320" y="16596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868320" y="16290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868320" y="15998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868320" y="15840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868320" y="15620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868320" y="15483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868320" y="15328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868320" y="14364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868320" y="13852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868320" y="13474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868320" y="13096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868320" y="12870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868320" y="12664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868320" y="12510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868320" y="12355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868320" y="12218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868320" y="11239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868320" y="10656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868320" y="10274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868320" y="99864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868320" y="9763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868320" y="9540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868320" y="9316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868320" y="9162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>
                <a:off x="868320" y="9025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868320" y="8128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>
                <a:off x="868320" y="7531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868320" y="7167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868320" y="6861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868320" y="6570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868320" y="64116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868320" y="61920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868320" y="60552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868320" y="589680"/>
                <a:ext cx="23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868320" y="2475720"/>
                <a:ext cx="31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868320" y="2164680"/>
                <a:ext cx="31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868320" y="1845360"/>
                <a:ext cx="31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868320" y="1532880"/>
                <a:ext cx="31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868320" y="1221840"/>
                <a:ext cx="31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868320" y="902520"/>
                <a:ext cx="31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868320" y="589680"/>
                <a:ext cx="313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868320" y="2475720"/>
                <a:ext cx="32961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 flipV="1">
                <a:off x="86832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 flipV="1">
                <a:off x="98100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 flipV="1">
                <a:off x="108468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 flipV="1">
                <a:off x="119592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 flipV="1">
                <a:off x="130860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 flipV="1">
                <a:off x="142128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 flipV="1">
                <a:off x="152496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 flipV="1">
                <a:off x="163548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 flipV="1">
                <a:off x="174816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 flipV="1">
                <a:off x="186120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 flipV="1">
                <a:off x="196452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 flipV="1">
                <a:off x="207576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 flipV="1">
                <a:off x="218844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 flipV="1">
                <a:off x="230112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 flipV="1">
                <a:off x="240480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 flipV="1">
                <a:off x="251532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 flipV="1">
                <a:off x="262836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 flipV="1">
                <a:off x="273168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 flipV="1">
                <a:off x="284436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 flipV="1">
                <a:off x="295740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 flipV="1">
                <a:off x="306828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 flipV="1">
                <a:off x="317196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 flipV="1">
                <a:off x="328464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 flipV="1">
                <a:off x="339732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 flipV="1">
                <a:off x="350820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 flipV="1">
                <a:off x="361152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 flipV="1">
                <a:off x="372456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 flipV="1">
                <a:off x="383724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 flipV="1">
                <a:off x="394812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 flipV="1">
                <a:off x="405180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 flipV="1">
                <a:off x="4164480" y="2445840"/>
                <a:ext cx="0" cy="29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728640" y="2430720"/>
                <a:ext cx="511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669960" y="21200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611640" y="18007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550800" y="148788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0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492840" y="1177200"/>
                <a:ext cx="2523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00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434520" y="857880"/>
                <a:ext cx="30240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000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375840" y="545040"/>
                <a:ext cx="35280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0000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 rot="16200000">
                <a:off x="833040" y="25855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2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 rot="16200000">
                <a:off x="1051560" y="25855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4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 rot="16200000">
                <a:off x="1282320" y="25855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6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 rot="16200000">
                <a:off x="1495080" y="25855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8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 rot="16200000">
                <a:off x="1695240" y="261252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0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 rot="16200000">
                <a:off x="1915560" y="260784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2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 rot="16200000">
                <a:off x="2138760" y="260784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4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 rot="16200000">
                <a:off x="2351520" y="260784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6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 rot="16200000">
                <a:off x="2576880" y="260784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18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 rot="16200000">
                <a:off x="2795400" y="260640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20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 rot="16200000">
                <a:off x="3017160" y="260784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22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 rot="16200000">
                <a:off x="3231360" y="261000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24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 rot="16200000">
                <a:off x="3447720" y="261144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26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 rot="16200000">
                <a:off x="3671280" y="261252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28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 rot="16200000">
                <a:off x="3889440" y="2613960"/>
                <a:ext cx="2019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宋体"/>
                  </a:rPr>
                  <a:t>30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58" name=""/>
            <p:cNvSpPr/>
            <p:nvPr/>
          </p:nvSpPr>
          <p:spPr>
            <a:xfrm>
              <a:off x="3635280" y="620640"/>
              <a:ext cx="432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9" name=""/>
          <p:cNvGrpSpPr/>
          <p:nvPr/>
        </p:nvGrpSpPr>
        <p:grpSpPr>
          <a:xfrm>
            <a:off x="4359960" y="404640"/>
            <a:ext cx="4172760" cy="2694240"/>
            <a:chOff x="4359960" y="404640"/>
            <a:chExt cx="4172760" cy="2694240"/>
          </a:xfrm>
        </p:grpSpPr>
        <p:graphicFrame>
          <p:nvGraphicFramePr>
            <p:cNvPr id="360" name=""/>
            <p:cNvGraphicFramePr/>
            <p:nvPr/>
          </p:nvGraphicFramePr>
          <p:xfrm>
            <a:off x="4421160" y="404640"/>
            <a:ext cx="4111560" cy="251784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361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4421160" y="404640"/>
                      <a:ext cx="4111560" cy="2517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362" name=""/>
            <p:cNvSpPr/>
            <p:nvPr/>
          </p:nvSpPr>
          <p:spPr>
            <a:xfrm>
              <a:off x="5826240" y="2852640"/>
              <a:ext cx="184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</a:rPr>
                <a:t>Scaffold length distribution (bp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4359960" y="1027080"/>
              <a:ext cx="332640" cy="124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Scaffold numb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7885080" y="620640"/>
              <a:ext cx="432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9T16:21:24Z</dcterms:created>
  <dc:creator>tclsevers</dc:creator>
  <dc:description/>
  <dc:language>en-US</dc:language>
  <cp:lastModifiedBy>tclsevers</cp:lastModifiedBy>
  <dcterms:modified xsi:type="dcterms:W3CDTF">2013-01-29T16:21:54Z</dcterms:modified>
  <cp:revision>1</cp:revision>
  <dc:subject/>
  <dc:title>幻灯片 1</dc:title>
</cp:coreProperties>
</file>